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rbani Francesca" initials="UF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B3B"/>
    <a:srgbClr val="FF5D5D"/>
    <a:srgbClr val="4D65D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22" autoAdjust="0"/>
  </p:normalViewPr>
  <p:slideViewPr>
    <p:cSldViewPr showGuides="1">
      <p:cViewPr>
        <p:scale>
          <a:sx n="99" d="100"/>
          <a:sy n="99" d="100"/>
        </p:scale>
        <p:origin x="-3558" y="17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705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167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425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225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008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2567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285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099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546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972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551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52ADA1-EBEA-471E-B411-ADB763F512A9}" type="datetimeFigureOut">
              <a:rPr lang="en-US" smtClean="0"/>
              <a:t>9/11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868346-AC56-4B27-AA84-C87769C787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5489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CasellaDiTesto 15"/>
          <p:cNvSpPr txBox="1"/>
          <p:nvPr/>
        </p:nvSpPr>
        <p:spPr>
          <a:xfrm>
            <a:off x="260648" y="500643"/>
            <a:ext cx="633670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S2.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egie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A) NK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D56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it-IT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NKT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D56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iv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ate and B) NK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set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i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D3 negativ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CD56 and CD16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K2, CD56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igh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D16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K4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D56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igh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D16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NK3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56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D16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NK1,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56</a:t>
            </a:r>
            <a:r>
              <a:rPr lang="it-IT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6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23" name="CasellaDiTesto 22"/>
          <p:cNvSpPr txBox="1"/>
          <p:nvPr/>
        </p:nvSpPr>
        <p:spPr>
          <a:xfrm>
            <a:off x="332656" y="159992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it-I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3429000" y="159992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it-IT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4250" y="1979712"/>
            <a:ext cx="2293043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1979712"/>
            <a:ext cx="2293043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CasellaDiTesto 1"/>
          <p:cNvSpPr txBox="1"/>
          <p:nvPr/>
        </p:nvSpPr>
        <p:spPr>
          <a:xfrm>
            <a:off x="1655932" y="4139952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smtClean="0"/>
              <a:t>CD3</a:t>
            </a:r>
            <a:endParaRPr lang="it-IT" sz="1400" dirty="0"/>
          </a:p>
        </p:txBody>
      </p:sp>
      <p:sp>
        <p:nvSpPr>
          <p:cNvPr id="18" name="CasellaDiTesto 17"/>
          <p:cNvSpPr txBox="1"/>
          <p:nvPr/>
        </p:nvSpPr>
        <p:spPr>
          <a:xfrm>
            <a:off x="4797152" y="4139952"/>
            <a:ext cx="5741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smtClean="0"/>
              <a:t>CD16</a:t>
            </a:r>
            <a:endParaRPr lang="it-IT" sz="1400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404664" y="2699792"/>
            <a:ext cx="400110" cy="48186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it-IT" sz="1400" dirty="0" smtClean="0"/>
              <a:t>CD56</a:t>
            </a:r>
            <a:endParaRPr lang="it-IT" sz="1400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3532946" y="2699792"/>
            <a:ext cx="400110" cy="48186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it-IT" sz="1400" dirty="0" smtClean="0"/>
              <a:t>CD56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35155520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7</TotalTime>
  <Words>72</Words>
  <Application>Microsoft Office PowerPoint</Application>
  <PresentationFormat>Presentazione su schermo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cchia Iole</dc:creator>
  <cp:lastModifiedBy>Urbani Francesca</cp:lastModifiedBy>
  <cp:revision>49</cp:revision>
  <dcterms:created xsi:type="dcterms:W3CDTF">2016-07-14T08:16:15Z</dcterms:created>
  <dcterms:modified xsi:type="dcterms:W3CDTF">2019-09-11T13:18:23Z</dcterms:modified>
</cp:coreProperties>
</file>